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6" d="100"/>
          <a:sy n="116" d="100"/>
        </p:scale>
        <p:origin x="2070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F4B7623-63E7-487D-973E-53E6C372B7BE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51D87F-BB39-43FA-B991-5F9C768E80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40338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151D87F-BB39-43FA-B991-5F9C768E80A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99128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8768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2383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648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85393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2682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08206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412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0731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29419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81646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63982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15876F-B54E-425F-A3FA-CDA6421036A0}" type="datetimeFigureOut">
              <a:rPr lang="en-US" smtClean="0"/>
              <a:t>5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A3C0FF-689D-40E3-ADC0-866BD2C3C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8290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986" y="457200"/>
            <a:ext cx="8189514" cy="30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143000" y="1092344"/>
            <a:ext cx="2926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endParaRPr lang="en-US" sz="12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886200" y="1094601"/>
            <a:ext cx="2926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endParaRPr lang="en-US" sz="12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8060116" y="1075467"/>
            <a:ext cx="3218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endParaRPr lang="en-US" sz="12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00200" y="4343400"/>
            <a:ext cx="78486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smtClean="0">
                <a:latin typeface="Arial" panose="020B0604020202020204" pitchFamily="34" charset="0"/>
                <a:cs typeface="Arial" panose="020B0604020202020204" pitchFamily="34" charset="0"/>
              </a:rPr>
              <a:t>S1 Fig. 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lucose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olerance in mice fed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ormal chow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iet.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fter a 5 hour fast, baseline glucose wa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easured, and animal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e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jecte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ith glucose (2 g/kg body weight) in isotonic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aline.  Serial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easurements of blood glucose levels were made at the indicated times up to 120 min. Blood glucose in male (A) and female (B)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lpp3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fl/</a:t>
            </a:r>
            <a:r>
              <a:rPr lang="en-US" sz="1200" i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; black symbols) and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P2-Cre/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lpp3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Δ; open symbols) mice are graphed as mean ± SD from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 animals/grou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ean area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nder the curve (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UC) is presented in C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85108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9</TotalTime>
  <Words>113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Office Theme</vt:lpstr>
      <vt:lpstr>PowerPoint Presentation</vt:lpstr>
    </vt:vector>
  </TitlesOfParts>
  <Company>University of Kentuck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myth, Susan</dc:creator>
  <cp:lastModifiedBy>McMullen, Colleen</cp:lastModifiedBy>
  <cp:revision>17</cp:revision>
  <dcterms:created xsi:type="dcterms:W3CDTF">2017-09-11T17:11:52Z</dcterms:created>
  <dcterms:modified xsi:type="dcterms:W3CDTF">2018-05-31T16:38:26Z</dcterms:modified>
  <cp:contentStatus>Final</cp:contentStatus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MarkAsFinal">
    <vt:bool>true</vt:bool>
  </property>
</Properties>
</file>